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60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3" autoAdjust="0"/>
    <p:restoredTop sz="94660"/>
  </p:normalViewPr>
  <p:slideViewPr>
    <p:cSldViewPr snapToGrid="0">
      <p:cViewPr varScale="1">
        <p:scale>
          <a:sx n="68" d="100"/>
          <a:sy n="68" d="100"/>
        </p:scale>
        <p:origin x="73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AD794F4-E24B-4C3A-8DE7-8644BA2523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88C3AD24-262E-48BC-A448-191201D62E2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3BA800E-ADA8-477B-BBFC-0A7F899F0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E49F798-FD2B-4130-ACB2-CCA3DC4B62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C38B6BB-288D-4171-BBDA-DBC99E46E3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8331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429BC7A-9904-4420-A177-0B4824DBF6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F283BAE-8F74-410B-9C96-6E81A5ADDF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9A8226A-468B-4546-BA59-89A6AE4B9C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31E441E-A9B1-4774-BC4F-BBA3F67BA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CB4BFE2-0F35-40C6-B2C3-D3D9A0705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6270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55869236-FDC7-4D96-8AED-B5D7E7581F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33B1EF50-7D2A-4748-B2F2-FC4D98C170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3E807BD-4786-4C20-8062-8D30011E4A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E7DCFD0-A0D1-4347-BA44-13D984572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ACFA070-029E-4735-BE88-D500ECF1CE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7512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4CB7339-993D-4FA5-983D-A25565452F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B47DAD3-E5E8-4B77-90EE-85559A52A9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9B53BDF-81F5-4F8F-AFDF-5A6B4AA9FF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29D9C04-42B6-4127-9843-4FA0C6F18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77C614B-1C4C-4D6D-A0D8-F1F0E90029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91894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90A6805-5391-4E95-9FE0-B47BF988E1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9AFC12C-9152-4F98-A17C-9BB4D51F80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70902CD-EFDF-4875-A521-8B4E3D081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5727A39-7441-4A35-9BE0-EA2CC1AFE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AC4AE2E-7F80-4136-9A9D-8495C05E6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0263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E3131A7-59FC-4143-AFB9-61D62FBD43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31187DF-B6CE-419F-8591-FEA7CB0077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F17C53F-EEBA-44A4-93C4-45FE81163A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7F3DFA8-CF3D-439D-A4ED-78C2E8B4A7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EE11231-4D9E-4E7E-BCD9-29E577E60F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78DBCEE-06D6-45E6-A437-9A13B38B5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19379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01A5D13-433A-4C32-9377-E9E9CB814A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96B9F03-B5D8-4411-AF29-0D6DBB765C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034E265-D882-4DF4-9616-C77492F73F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9956D15D-844B-41D2-9C3C-C28AA875E6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AE304CC8-348C-4DCE-9D90-43DADF4939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C86BCF52-C358-43AA-9AF6-40F6D0FA0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70C02941-E7D3-4F3A-818E-FBF43D25A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6C21B59-AC8C-4F42-BA4D-4BBDEDCC5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8302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E2FCBAB-BD40-4C04-B815-B861D74745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FF55B1DB-BEA0-4D8A-8F3D-EFFDFA5EC1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23D4AA13-C723-47DD-AE5D-73E7DA4F33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72C6CC98-7162-4B63-9D10-73387AAD3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2505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5E06B809-293D-4A41-980C-41F6E8EC74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92783A2A-84E3-4E5D-BC51-18D66AE27D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3C0139A-BD26-4D58-BA2D-4C4FFB2E1A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991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82F73F1-1F5E-47BE-9822-7E8D75CBF3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CAA0D1B-CF27-4B03-819E-D30A047BDB0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27CEC52-2772-4F6A-9ACB-4356295024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39EC593-D518-4752-8BF9-36A51FC5E9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1BF9124-C299-487E-87F0-5104F30273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9D7E7BC-F925-4847-8636-7370A4F227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7293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7A4B86D-21AE-459A-B75D-444345B57A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4E9E3C4-9994-458F-B88B-3D1EB2F14B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D3254EA-5F8A-467F-ADC6-16F1533EEE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25A3CAB-D840-486C-9249-BEE944D01A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007D05F-2401-4BE9-A2C9-29E32A6952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8EC34F3-15C8-479A-90C6-70CE0D6469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5327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B40E1D7-86FC-4335-BC71-47C3751E99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FB86F34-1E8F-4059-B9E8-231681B13B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C3D2838-EAC2-4351-93C6-833B389258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096AB80-D735-4F56-B486-DFADE9AD98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0C81C39-724B-4D61-BD6A-9A3850C719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76172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7" name="Picture 11" descr="J1 male normal media">
            <a:extLst>
              <a:ext uri="{FF2B5EF4-FFF2-40B4-BE49-F238E27FC236}">
                <a16:creationId xmlns:a16="http://schemas.microsoft.com/office/drawing/2014/main" id="{C92B281F-897B-43D7-B40B-7395F9329A9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90046" y="2647203"/>
            <a:ext cx="1079897" cy="11156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388" name="Text Box 12">
            <a:extLst>
              <a:ext uri="{FF2B5EF4-FFF2-40B4-BE49-F238E27FC236}">
                <a16:creationId xmlns:a16="http://schemas.microsoft.com/office/drawing/2014/main" id="{0E86B7CE-3DF3-4FCA-A323-A23D270C71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01387" y="2174871"/>
            <a:ext cx="971740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No capsaicin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in food</a:t>
            </a:r>
          </a:p>
        </p:txBody>
      </p:sp>
      <p:sp>
        <p:nvSpPr>
          <p:cNvPr id="16389" name="Text Box 13">
            <a:extLst>
              <a:ext uri="{FF2B5EF4-FFF2-40B4-BE49-F238E27FC236}">
                <a16:creationId xmlns:a16="http://schemas.microsoft.com/office/drawing/2014/main" id="{7BAAE8DF-6F62-445A-B5C6-4B89018C71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02622" y="2163697"/>
            <a:ext cx="1271502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apsaicin (5 mM)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in food</a:t>
            </a:r>
          </a:p>
        </p:txBody>
      </p:sp>
      <p:pic>
        <p:nvPicPr>
          <p:cNvPr id="16390" name="Picture 14">
            <a:extLst>
              <a:ext uri="{FF2B5EF4-FFF2-40B4-BE49-F238E27FC236}">
                <a16:creationId xmlns:a16="http://schemas.microsoft.com/office/drawing/2014/main" id="{53D0F6E8-2B62-4479-B32E-2090CE1F235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79958" y="2676229"/>
            <a:ext cx="1079897" cy="10346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392" name="TextBox 10">
            <a:extLst>
              <a:ext uri="{FF2B5EF4-FFF2-40B4-BE49-F238E27FC236}">
                <a16:creationId xmlns:a16="http://schemas.microsoft.com/office/drawing/2014/main" id="{D1E53501-0D9E-4BE7-84E2-7BFD1E70B2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7938" y="518198"/>
            <a:ext cx="55335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 S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93" name="TextBox 2">
            <a:extLst>
              <a:ext uri="{FF2B5EF4-FFF2-40B4-BE49-F238E27FC236}">
                <a16:creationId xmlns:a16="http://schemas.microsoft.com/office/drawing/2014/main" id="{159A621D-FC37-4F48-A574-FC67140D5C8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1556" y="1431437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94" name="TextBox 13">
            <a:extLst>
              <a:ext uri="{FF2B5EF4-FFF2-40B4-BE49-F238E27FC236}">
                <a16:creationId xmlns:a16="http://schemas.microsoft.com/office/drawing/2014/main" id="{FA21B614-5A0D-4C22-BB6C-29F3AE89E1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65288" y="1431437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95" name="TextBox 14">
            <a:extLst>
              <a:ext uri="{FF2B5EF4-FFF2-40B4-BE49-F238E27FC236}">
                <a16:creationId xmlns:a16="http://schemas.microsoft.com/office/drawing/2014/main" id="{3012DDFB-F9F7-470D-B002-C3C0D81E94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39736" y="1431437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4ACCA49-6E91-437D-B189-06E670F4F9CD}"/>
              </a:ext>
            </a:extLst>
          </p:cNvPr>
          <p:cNvSpPr txBox="1"/>
          <p:nvPr/>
        </p:nvSpPr>
        <p:spPr>
          <a:xfrm rot="16200000">
            <a:off x="8440625" y="2819242"/>
            <a:ext cx="876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% Weight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7631A33-5924-44FB-8FDE-23E24A0BF50D}"/>
              </a:ext>
            </a:extLst>
          </p:cNvPr>
          <p:cNvSpPr txBox="1"/>
          <p:nvPr/>
        </p:nvSpPr>
        <p:spPr>
          <a:xfrm>
            <a:off x="10569921" y="2597431"/>
            <a:ext cx="804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3760BA3-F9BF-4F1D-AD59-C90A12ED977A}"/>
              </a:ext>
            </a:extLst>
          </p:cNvPr>
          <p:cNvSpPr txBox="1"/>
          <p:nvPr/>
        </p:nvSpPr>
        <p:spPr>
          <a:xfrm>
            <a:off x="9568157" y="3631190"/>
            <a:ext cx="13680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ime (hours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4A02AC0-59E2-4CFC-BABE-9CE96EA58E82}"/>
              </a:ext>
            </a:extLst>
          </p:cNvPr>
          <p:cNvSpPr txBox="1"/>
          <p:nvPr/>
        </p:nvSpPr>
        <p:spPr>
          <a:xfrm>
            <a:off x="10569921" y="2330089"/>
            <a:ext cx="804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C5728AD2-1284-4442-8D00-E9FC1B1C0B0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03874" y="1888665"/>
            <a:ext cx="1240031" cy="1530756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D9074B88-6B6E-49D3-B5C2-37F104BFEF1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78204" y="2357742"/>
            <a:ext cx="330732" cy="452581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82870883-56F0-4408-9C19-3B125F8BC3A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77045" y="2833962"/>
            <a:ext cx="330733" cy="7847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87360E2-FB31-49DD-A367-6236021C21C1}"/>
              </a:ext>
            </a:extLst>
          </p:cNvPr>
          <p:cNvSpPr txBox="1"/>
          <p:nvPr/>
        </p:nvSpPr>
        <p:spPr>
          <a:xfrm rot="16200000">
            <a:off x="458134" y="2554956"/>
            <a:ext cx="996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% Viability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7CD86BD-037C-41B4-8AC1-60B42DEE11F9}"/>
              </a:ext>
            </a:extLst>
          </p:cNvPr>
          <p:cNvSpPr txBox="1"/>
          <p:nvPr/>
        </p:nvSpPr>
        <p:spPr>
          <a:xfrm>
            <a:off x="1439486" y="3559942"/>
            <a:ext cx="10363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ime (days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72308B5-2D53-4D72-923C-727B5A9229D3}"/>
              </a:ext>
            </a:extLst>
          </p:cNvPr>
          <p:cNvSpPr txBox="1"/>
          <p:nvPr/>
        </p:nvSpPr>
        <p:spPr>
          <a:xfrm>
            <a:off x="3648490" y="2602617"/>
            <a:ext cx="10615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apsaicin </a:t>
            </a:r>
          </a:p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in food (5 mM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8B91ABC-2172-432A-BAF9-A1EEDD844641}"/>
              </a:ext>
            </a:extLst>
          </p:cNvPr>
          <p:cNvSpPr txBox="1"/>
          <p:nvPr/>
        </p:nvSpPr>
        <p:spPr>
          <a:xfrm>
            <a:off x="2683408" y="2254683"/>
            <a:ext cx="98937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md-TRPV1(3)</a:t>
            </a:r>
          </a:p>
          <a:p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md-Gal4</a:t>
            </a:r>
          </a:p>
          <a:p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md-TRPV1(3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md-Gal4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342D867-B9B4-43A1-A40D-C333E668D24B}"/>
              </a:ext>
            </a:extLst>
          </p:cNvPr>
          <p:cNvSpPr txBox="1"/>
          <p:nvPr/>
        </p:nvSpPr>
        <p:spPr>
          <a:xfrm>
            <a:off x="3648490" y="2328317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tarved</a:t>
            </a:r>
          </a:p>
        </p:txBody>
      </p: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5803564B-6532-4754-9FDB-E0C98EEF6259}"/>
              </a:ext>
            </a:extLst>
          </p:cNvPr>
          <p:cNvCxnSpPr>
            <a:cxnSpLocks/>
          </p:cNvCxnSpPr>
          <p:nvPr/>
        </p:nvCxnSpPr>
        <p:spPr>
          <a:xfrm>
            <a:off x="3643090" y="2333990"/>
            <a:ext cx="0" cy="25088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직선 연결선 29">
            <a:extLst>
              <a:ext uri="{FF2B5EF4-FFF2-40B4-BE49-F238E27FC236}">
                <a16:creationId xmlns:a16="http://schemas.microsoft.com/office/drawing/2014/main" id="{86B4ACF5-E11B-4808-8A35-989BCC011525}"/>
              </a:ext>
            </a:extLst>
          </p:cNvPr>
          <p:cNvCxnSpPr/>
          <p:nvPr/>
        </p:nvCxnSpPr>
        <p:spPr>
          <a:xfrm>
            <a:off x="3643090" y="2686797"/>
            <a:ext cx="0" cy="25088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9C623691-4DD0-4AA7-8049-0D74EB9AFF8F}"/>
              </a:ext>
            </a:extLst>
          </p:cNvPr>
          <p:cNvSpPr txBox="1"/>
          <p:nvPr/>
        </p:nvSpPr>
        <p:spPr>
          <a:xfrm>
            <a:off x="8901188" y="227251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1A60B06-142E-432D-BE89-997F22CC7A33}"/>
              </a:ext>
            </a:extLst>
          </p:cNvPr>
          <p:cNvSpPr txBox="1"/>
          <p:nvPr/>
        </p:nvSpPr>
        <p:spPr>
          <a:xfrm>
            <a:off x="9380336" y="3430939"/>
            <a:ext cx="15616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0            21          28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그림 9">
            <a:extLst>
              <a:ext uri="{FF2B5EF4-FFF2-40B4-BE49-F238E27FC236}">
                <a16:creationId xmlns:a16="http://schemas.microsoft.com/office/drawing/2014/main" id="{20EF9D45-CAC6-4EF3-A12A-52806101D95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393788" y="2287435"/>
            <a:ext cx="1219155" cy="549815"/>
          </a:xfrm>
          <a:prstGeom prst="rect">
            <a:avLst/>
          </a:prstGeom>
        </p:spPr>
      </p:pic>
      <p:cxnSp>
        <p:nvCxnSpPr>
          <p:cNvPr id="13" name="직선 연결선 12">
            <a:extLst>
              <a:ext uri="{FF2B5EF4-FFF2-40B4-BE49-F238E27FC236}">
                <a16:creationId xmlns:a16="http://schemas.microsoft.com/office/drawing/2014/main" id="{EDF056E2-255C-4F18-9D49-25AF60413BB6}"/>
              </a:ext>
            </a:extLst>
          </p:cNvPr>
          <p:cNvCxnSpPr/>
          <p:nvPr/>
        </p:nvCxnSpPr>
        <p:spPr>
          <a:xfrm>
            <a:off x="9286560" y="2366252"/>
            <a:ext cx="0" cy="10801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연결선 20">
            <a:extLst>
              <a:ext uri="{FF2B5EF4-FFF2-40B4-BE49-F238E27FC236}">
                <a16:creationId xmlns:a16="http://schemas.microsoft.com/office/drawing/2014/main" id="{04B92D48-3A95-4DD7-97DF-902DD0639C8C}"/>
              </a:ext>
            </a:extLst>
          </p:cNvPr>
          <p:cNvCxnSpPr/>
          <p:nvPr/>
        </p:nvCxnSpPr>
        <p:spPr>
          <a:xfrm>
            <a:off x="9286561" y="3431015"/>
            <a:ext cx="14057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연결선 27">
            <a:extLst>
              <a:ext uri="{FF2B5EF4-FFF2-40B4-BE49-F238E27FC236}">
                <a16:creationId xmlns:a16="http://schemas.microsoft.com/office/drawing/2014/main" id="{9661458A-589F-422B-9B24-8C34527FC1DD}"/>
              </a:ext>
            </a:extLst>
          </p:cNvPr>
          <p:cNvCxnSpPr>
            <a:cxnSpLocks/>
          </p:cNvCxnSpPr>
          <p:nvPr/>
        </p:nvCxnSpPr>
        <p:spPr>
          <a:xfrm flipV="1">
            <a:off x="9499686" y="3366686"/>
            <a:ext cx="0" cy="6433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직선 연결선 43">
            <a:extLst>
              <a:ext uri="{FF2B5EF4-FFF2-40B4-BE49-F238E27FC236}">
                <a16:creationId xmlns:a16="http://schemas.microsoft.com/office/drawing/2014/main" id="{DF41B6E1-B057-4E1E-9307-201E34AE0620}"/>
              </a:ext>
            </a:extLst>
          </p:cNvPr>
          <p:cNvCxnSpPr>
            <a:cxnSpLocks/>
          </p:cNvCxnSpPr>
          <p:nvPr/>
        </p:nvCxnSpPr>
        <p:spPr>
          <a:xfrm>
            <a:off x="9272088" y="2887669"/>
            <a:ext cx="5072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연결선 45">
            <a:extLst>
              <a:ext uri="{FF2B5EF4-FFF2-40B4-BE49-F238E27FC236}">
                <a16:creationId xmlns:a16="http://schemas.microsoft.com/office/drawing/2014/main" id="{50BD89DA-A712-4C7A-A794-0E2220AA4B77}"/>
              </a:ext>
            </a:extLst>
          </p:cNvPr>
          <p:cNvCxnSpPr>
            <a:cxnSpLocks/>
          </p:cNvCxnSpPr>
          <p:nvPr/>
        </p:nvCxnSpPr>
        <p:spPr>
          <a:xfrm flipV="1">
            <a:off x="10003742" y="3366014"/>
            <a:ext cx="0" cy="6433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직선 연결선 46">
            <a:extLst>
              <a:ext uri="{FF2B5EF4-FFF2-40B4-BE49-F238E27FC236}">
                <a16:creationId xmlns:a16="http://schemas.microsoft.com/office/drawing/2014/main" id="{FEE89BF6-A8D4-41CD-AE7B-61387A7FE158}"/>
              </a:ext>
            </a:extLst>
          </p:cNvPr>
          <p:cNvCxnSpPr>
            <a:cxnSpLocks/>
          </p:cNvCxnSpPr>
          <p:nvPr/>
        </p:nvCxnSpPr>
        <p:spPr>
          <a:xfrm flipV="1">
            <a:off x="10533510" y="3362117"/>
            <a:ext cx="0" cy="6433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>
            <a:extLst>
              <a:ext uri="{FF2B5EF4-FFF2-40B4-BE49-F238E27FC236}">
                <a16:creationId xmlns:a16="http://schemas.microsoft.com/office/drawing/2014/main" id="{7339EBF1-FA3A-4549-8707-E77A5DE73D02}"/>
              </a:ext>
            </a:extLst>
          </p:cNvPr>
          <p:cNvCxnSpPr>
            <a:cxnSpLocks/>
          </p:cNvCxnSpPr>
          <p:nvPr/>
        </p:nvCxnSpPr>
        <p:spPr>
          <a:xfrm>
            <a:off x="9281098" y="2366252"/>
            <a:ext cx="5072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869DCA6E-093D-4364-86FF-B00AC453EB32}"/>
              </a:ext>
            </a:extLst>
          </p:cNvPr>
          <p:cNvSpPr txBox="1"/>
          <p:nvPr/>
        </p:nvSpPr>
        <p:spPr>
          <a:xfrm>
            <a:off x="1595446" y="338345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580FF20-B56F-4B23-8F8D-56CAB41503CC}"/>
              </a:ext>
            </a:extLst>
          </p:cNvPr>
          <p:cNvSpPr txBox="1"/>
          <p:nvPr/>
        </p:nvSpPr>
        <p:spPr>
          <a:xfrm>
            <a:off x="1999879" y="338345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E8F180E-D86C-41E8-A206-C4CBF7FC11E3}"/>
              </a:ext>
            </a:extLst>
          </p:cNvPr>
          <p:cNvSpPr txBox="1"/>
          <p:nvPr/>
        </p:nvSpPr>
        <p:spPr>
          <a:xfrm>
            <a:off x="978333" y="196496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7895695-0278-43F8-93D5-D6AC384F436A}"/>
              </a:ext>
            </a:extLst>
          </p:cNvPr>
          <p:cNvSpPr txBox="1"/>
          <p:nvPr/>
        </p:nvSpPr>
        <p:spPr>
          <a:xfrm>
            <a:off x="1048865" y="219950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D702030-75C4-454D-AB7B-66872F2524CD}"/>
              </a:ext>
            </a:extLst>
          </p:cNvPr>
          <p:cNvSpPr txBox="1"/>
          <p:nvPr/>
        </p:nvSpPr>
        <p:spPr>
          <a:xfrm>
            <a:off x="1048865" y="248337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1AF23BD-8C97-42CB-8CFF-4B648A7D9CF4}"/>
              </a:ext>
            </a:extLst>
          </p:cNvPr>
          <p:cNvSpPr txBox="1"/>
          <p:nvPr/>
        </p:nvSpPr>
        <p:spPr>
          <a:xfrm>
            <a:off x="1048865" y="27322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C92E2EF-1A85-4605-A2B9-29263F51C9D0}"/>
              </a:ext>
            </a:extLst>
          </p:cNvPr>
          <p:cNvSpPr txBox="1"/>
          <p:nvPr/>
        </p:nvSpPr>
        <p:spPr>
          <a:xfrm>
            <a:off x="1048865" y="297170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D25E54A-E0CB-4739-A8BC-C0E85F8F5080}"/>
              </a:ext>
            </a:extLst>
          </p:cNvPr>
          <p:cNvSpPr txBox="1"/>
          <p:nvPr/>
        </p:nvSpPr>
        <p:spPr>
          <a:xfrm>
            <a:off x="1119397" y="323421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57C42D9-1785-4BF6-A133-2CA376C24EEA}"/>
              </a:ext>
            </a:extLst>
          </p:cNvPr>
          <p:cNvSpPr txBox="1"/>
          <p:nvPr/>
        </p:nvSpPr>
        <p:spPr>
          <a:xfrm>
            <a:off x="8971720" y="279082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 Box 6">
            <a:extLst>
              <a:ext uri="{FF2B5EF4-FFF2-40B4-BE49-F238E27FC236}">
                <a16:creationId xmlns:a16="http://schemas.microsoft.com/office/drawing/2014/main" id="{0678BB22-C123-470C-B4DD-BA2BA883E65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73750" y="1813811"/>
            <a:ext cx="154401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md-TRPV1(3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flies</a:t>
            </a:r>
          </a:p>
        </p:txBody>
      </p:sp>
      <p:cxnSp>
        <p:nvCxnSpPr>
          <p:cNvPr id="14" name="직선 연결선 13">
            <a:extLst>
              <a:ext uri="{FF2B5EF4-FFF2-40B4-BE49-F238E27FC236}">
                <a16:creationId xmlns:a16="http://schemas.microsoft.com/office/drawing/2014/main" id="{DA7F6A83-527C-481C-AB42-D30DE8F4416E}"/>
              </a:ext>
            </a:extLst>
          </p:cNvPr>
          <p:cNvCxnSpPr/>
          <p:nvPr/>
        </p:nvCxnSpPr>
        <p:spPr>
          <a:xfrm>
            <a:off x="5349834" y="2095995"/>
            <a:ext cx="204255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 Box 6">
            <a:extLst>
              <a:ext uri="{FF2B5EF4-FFF2-40B4-BE49-F238E27FC236}">
                <a16:creationId xmlns:a16="http://schemas.microsoft.com/office/drawing/2014/main" id="{3B3BB84B-5BA1-4564-95FC-0A7133BB3D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98742" y="1621826"/>
            <a:ext cx="154401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md-TRPV1(3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flies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29F765A-D3ED-4331-BADA-C71FF2391F45}"/>
              </a:ext>
            </a:extLst>
          </p:cNvPr>
          <p:cNvSpPr txBox="1"/>
          <p:nvPr/>
        </p:nvSpPr>
        <p:spPr>
          <a:xfrm>
            <a:off x="10323561" y="1953348"/>
            <a:ext cx="12759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apsaicin</a:t>
            </a:r>
          </a:p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in food (m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38108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7</TotalTime>
  <Words>71</Words>
  <Application>Microsoft Office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Saranya Siva</cp:lastModifiedBy>
  <cp:revision>149</cp:revision>
  <dcterms:created xsi:type="dcterms:W3CDTF">2022-10-18T02:31:52Z</dcterms:created>
  <dcterms:modified xsi:type="dcterms:W3CDTF">2023-02-08T08:35:25Z</dcterms:modified>
</cp:coreProperties>
</file>